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74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E2F7"/>
    <a:srgbClr val="0432FF"/>
    <a:srgbClr val="CDD8ED"/>
    <a:srgbClr val="C3CDDE"/>
    <a:srgbClr val="C4CFE2"/>
    <a:srgbClr val="C6D3E7"/>
    <a:srgbClr val="011893"/>
    <a:srgbClr val="FF2F92"/>
    <a:srgbClr val="FF40FF"/>
    <a:srgbClr val="0054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17292A2E-F333-43FB-9621-5CBBE7FDCDCB}" styleName="淡色スタイル 2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B9631B5-78F2-41C9-869B-9F39066F8104}" styleName="中間スタイル 3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0505E3EF-67EA-436B-97B2-0124C06EBD24}" styleName="中間スタイル 4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83"/>
    <p:restoredTop sz="80502"/>
  </p:normalViewPr>
  <p:slideViewPr>
    <p:cSldViewPr snapToGrid="0" snapToObjects="1">
      <p:cViewPr varScale="1">
        <p:scale>
          <a:sx n="89" d="100"/>
          <a:sy n="89" d="100"/>
        </p:scale>
        <p:origin x="2352" y="16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BFEBEE58-A750-C141-93A3-860CCA5CFAB7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778EBB2-E55E-1A47-BCBA-FE4933C27D5C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504547-8C12-E843-B854-275ED5B05DE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F19E64E-7BB4-C74D-B2B8-C7E35E8AC07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0C22731-5BE6-A648-A795-34A25D7DCA2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7FDC10-B8D4-164A-9C52-A0644A2A9E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0287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1A0E0C-37C2-0A4D-9D04-C5C61917D07B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3DBAE5-6F8C-5640-A312-6B5E61E056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068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2: Fig. 2 Mosaic ratio resul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G-band. Metaphase and interphase FISH using probe for CEPY(Red) and 22q11.2 (Green, RP11-278E23). (B) Percentage of two cell lines.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3DBAE5-6F8C-5640-A312-6B5E61E0569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0183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92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6501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763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08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87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084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156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815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38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380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44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57AF2-6351-3E40-849A-A7326D9622B5}" type="datetimeFigureOut">
              <a:rPr kumimoji="1" lang="ja-JP" altLang="en-US" smtClean="0"/>
              <a:t>2021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739F9-8B37-DC49-A679-9BE06B3D1D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223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8309605-2F98-2344-8307-78FA030F27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6667" y="1248804"/>
            <a:ext cx="2344553" cy="1930164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E0832DA5-386F-F041-A895-E39772D919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902" y="1248804"/>
            <a:ext cx="2354965" cy="1930164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B6FB5ED-836A-8F4D-B52F-7DEC4CD7FCBD}"/>
              </a:ext>
            </a:extLst>
          </p:cNvPr>
          <p:cNvSpPr/>
          <p:nvPr/>
        </p:nvSpPr>
        <p:spPr>
          <a:xfrm>
            <a:off x="218902" y="843522"/>
            <a:ext cx="435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 defTabSz="914400">
              <a:defRPr/>
            </a:pPr>
            <a:r>
              <a:rPr kumimoji="1" lang="en-IN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45,X,dic(Y;22)(p11.3;p11.2)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E29530AE-CCF8-7C46-87F6-FA3F1B84D2EB}"/>
              </a:ext>
            </a:extLst>
          </p:cNvPr>
          <p:cNvSpPr/>
          <p:nvPr/>
        </p:nvSpPr>
        <p:spPr>
          <a:xfrm>
            <a:off x="4654294" y="838315"/>
            <a:ext cx="439608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 defTabSz="914400">
              <a:defRPr/>
            </a:pPr>
            <a:r>
              <a:rPr kumimoji="1" lang="en-IN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45,X</a:t>
            </a:r>
          </a:p>
        </p:txBody>
      </p:sp>
      <p:graphicFrame>
        <p:nvGraphicFramePr>
          <p:cNvPr id="14" name="表 2">
            <a:extLst>
              <a:ext uri="{FF2B5EF4-FFF2-40B4-BE49-F238E27FC236}">
                <a16:creationId xmlns:a16="http://schemas.microsoft.com/office/drawing/2014/main" id="{FF821DD3-1174-284C-8A76-C5A77D5425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1937614"/>
              </p:ext>
            </p:extLst>
          </p:nvPr>
        </p:nvGraphicFramePr>
        <p:xfrm>
          <a:off x="901261" y="3411915"/>
          <a:ext cx="7665156" cy="1483360"/>
        </p:xfrm>
        <a:graphic>
          <a:graphicData uri="http://schemas.openxmlformats.org/drawingml/2006/table">
            <a:tbl>
              <a:tblPr bandRow="1">
                <a:tableStyleId>{2D5ABB26-0587-4C30-8999-92F81FD0307C}</a:tableStyleId>
              </a:tblPr>
              <a:tblGrid>
                <a:gridCol w="1916289">
                  <a:extLst>
                    <a:ext uri="{9D8B030D-6E8A-4147-A177-3AD203B41FA5}">
                      <a16:colId xmlns:a16="http://schemas.microsoft.com/office/drawing/2014/main" val="232490764"/>
                    </a:ext>
                  </a:extLst>
                </a:gridCol>
                <a:gridCol w="1916289">
                  <a:extLst>
                    <a:ext uri="{9D8B030D-6E8A-4147-A177-3AD203B41FA5}">
                      <a16:colId xmlns:a16="http://schemas.microsoft.com/office/drawing/2014/main" val="1713475549"/>
                    </a:ext>
                  </a:extLst>
                </a:gridCol>
                <a:gridCol w="1916289">
                  <a:extLst>
                    <a:ext uri="{9D8B030D-6E8A-4147-A177-3AD203B41FA5}">
                      <a16:colId xmlns:a16="http://schemas.microsoft.com/office/drawing/2014/main" val="3836141446"/>
                    </a:ext>
                  </a:extLst>
                </a:gridCol>
                <a:gridCol w="1916289">
                  <a:extLst>
                    <a:ext uri="{9D8B030D-6E8A-4147-A177-3AD203B41FA5}">
                      <a16:colId xmlns:a16="http://schemas.microsoft.com/office/drawing/2014/main" val="184895946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X,dic(Y;22)</a:t>
                      </a:r>
                      <a:endParaRPr kumimoji="1" lang="ja-JP" altLang="en-US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X</a:t>
                      </a:r>
                      <a:endParaRPr kumimoji="1" lang="ja-JP" altLang="en-US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kumimoji="1" lang="ja-JP" altLang="en-US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99778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band 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 [92%]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[8%]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08462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phase FISH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 [85%]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[15%]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64010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phase FISH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 [87.5%]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25 [12.5%]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7331638"/>
                  </a:ext>
                </a:extLst>
              </a:tr>
            </a:tbl>
          </a:graphicData>
        </a:graphic>
      </p:graphicFrame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A3029D52-1D45-9D4C-ACD1-38AB997EB59B}"/>
              </a:ext>
            </a:extLst>
          </p:cNvPr>
          <p:cNvGrpSpPr/>
          <p:nvPr/>
        </p:nvGrpSpPr>
        <p:grpSpPr>
          <a:xfrm>
            <a:off x="2580352" y="1248804"/>
            <a:ext cx="2028309" cy="1937063"/>
            <a:chOff x="2726656" y="1248804"/>
            <a:chExt cx="2028309" cy="1937063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5B0397AD-260D-244E-BB15-D8D7602920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043" r="202" b="5559"/>
            <a:stretch/>
          </p:blipFill>
          <p:spPr>
            <a:xfrm>
              <a:off x="2726656" y="1248804"/>
              <a:ext cx="1851262" cy="19301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3" name="直線矢印コネクタ 22">
              <a:extLst>
                <a:ext uri="{FF2B5EF4-FFF2-40B4-BE49-F238E27FC236}">
                  <a16:creationId xmlns:a16="http://schemas.microsoft.com/office/drawing/2014/main" id="{E79DC166-E696-DB47-9661-5F8A6DD02C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83438" y="2651321"/>
              <a:ext cx="68373" cy="11726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3" name="図 32">
              <a:extLst>
                <a:ext uri="{FF2B5EF4-FFF2-40B4-BE49-F238E27FC236}">
                  <a16:creationId xmlns:a16="http://schemas.microsoft.com/office/drawing/2014/main" id="{363F096F-6A6E-4E43-B0EE-8ADB1D736B2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32118" y="2530664"/>
              <a:ext cx="622847" cy="65520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9231C7EF-498F-7D44-95F3-A393E0F61244}"/>
              </a:ext>
            </a:extLst>
          </p:cNvPr>
          <p:cNvGrpSpPr/>
          <p:nvPr/>
        </p:nvGrpSpPr>
        <p:grpSpPr>
          <a:xfrm>
            <a:off x="7023505" y="1248804"/>
            <a:ext cx="2026877" cy="1931632"/>
            <a:chOff x="7102296" y="1248804"/>
            <a:chExt cx="2026877" cy="1931632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C88CAE55-E076-444D-AE8F-01A929330C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678" t="10156" r="3064" b="1047"/>
            <a:stretch/>
          </p:blipFill>
          <p:spPr>
            <a:xfrm rot="16200000">
              <a:off x="7062845" y="1288255"/>
              <a:ext cx="1930163" cy="18512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00A1B814-E58A-DC43-AB44-01CA0B0EB71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506326" y="2537498"/>
              <a:ext cx="622847" cy="64293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67CBC5A-BB7C-4E48-A153-BC788572C352}"/>
              </a:ext>
            </a:extLst>
          </p:cNvPr>
          <p:cNvSpPr txBox="1"/>
          <p:nvPr/>
        </p:nvSpPr>
        <p:spPr>
          <a:xfrm>
            <a:off x="8738958" y="2494718"/>
            <a:ext cx="447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667FB4D-05FE-8A46-B4A0-8CF15125246F}"/>
              </a:ext>
            </a:extLst>
          </p:cNvPr>
          <p:cNvSpPr txBox="1"/>
          <p:nvPr/>
        </p:nvSpPr>
        <p:spPr>
          <a:xfrm>
            <a:off x="8778186" y="2935045"/>
            <a:ext cx="447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EF7837C-0639-A143-B5CB-792045DCBB80}"/>
              </a:ext>
            </a:extLst>
          </p:cNvPr>
          <p:cNvSpPr txBox="1"/>
          <p:nvPr/>
        </p:nvSpPr>
        <p:spPr>
          <a:xfrm>
            <a:off x="7921215" y="1594643"/>
            <a:ext cx="447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7F53F20-2A97-574C-9645-962D01F08E03}"/>
              </a:ext>
            </a:extLst>
          </p:cNvPr>
          <p:cNvSpPr txBox="1"/>
          <p:nvPr/>
        </p:nvSpPr>
        <p:spPr>
          <a:xfrm>
            <a:off x="7782317" y="2319016"/>
            <a:ext cx="447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D215413-3278-B941-8C41-8C6352927A4D}"/>
              </a:ext>
            </a:extLst>
          </p:cNvPr>
          <p:cNvSpPr txBox="1"/>
          <p:nvPr/>
        </p:nvSpPr>
        <p:spPr>
          <a:xfrm>
            <a:off x="4161430" y="2660864"/>
            <a:ext cx="447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6AFF8EF-F876-984A-908A-9655C54128D3}"/>
              </a:ext>
            </a:extLst>
          </p:cNvPr>
          <p:cNvSpPr txBox="1"/>
          <p:nvPr/>
        </p:nvSpPr>
        <p:spPr>
          <a:xfrm>
            <a:off x="3921746" y="3013488"/>
            <a:ext cx="8530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(Y;22)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301F715-D429-C242-B130-80D6FE8E4C55}"/>
              </a:ext>
            </a:extLst>
          </p:cNvPr>
          <p:cNvSpPr txBox="1"/>
          <p:nvPr/>
        </p:nvSpPr>
        <p:spPr>
          <a:xfrm>
            <a:off x="2940991" y="1617726"/>
            <a:ext cx="447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6442F01-1A8F-984F-B385-31EB9A613DCE}"/>
              </a:ext>
            </a:extLst>
          </p:cNvPr>
          <p:cNvSpPr txBox="1"/>
          <p:nvPr/>
        </p:nvSpPr>
        <p:spPr>
          <a:xfrm>
            <a:off x="2847394" y="2796002"/>
            <a:ext cx="8530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c(Y;22)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21562B1A-E032-B74D-94FE-5AC41D3FC57E}"/>
              </a:ext>
            </a:extLst>
          </p:cNvPr>
          <p:cNvCxnSpPr>
            <a:cxnSpLocks/>
          </p:cNvCxnSpPr>
          <p:nvPr/>
        </p:nvCxnSpPr>
        <p:spPr>
          <a:xfrm flipV="1">
            <a:off x="4090819" y="2928598"/>
            <a:ext cx="0" cy="12567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7C31B2D-CB13-4443-B14C-16DD7DEDFC51}"/>
              </a:ext>
            </a:extLst>
          </p:cNvPr>
          <p:cNvSpPr txBox="1"/>
          <p:nvPr/>
        </p:nvSpPr>
        <p:spPr>
          <a:xfrm>
            <a:off x="-40359" y="778773"/>
            <a:ext cx="6582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5182576-D405-BA4E-B497-9EC81F82F6FE}"/>
              </a:ext>
            </a:extLst>
          </p:cNvPr>
          <p:cNvSpPr txBox="1"/>
          <p:nvPr/>
        </p:nvSpPr>
        <p:spPr>
          <a:xfrm>
            <a:off x="16281" y="3351981"/>
            <a:ext cx="6582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9FC9C99D-A9A8-DB42-AA7B-DBD7D0411078}"/>
              </a:ext>
            </a:extLst>
          </p:cNvPr>
          <p:cNvSpPr/>
          <p:nvPr/>
        </p:nvSpPr>
        <p:spPr>
          <a:xfrm>
            <a:off x="119895" y="111254"/>
            <a:ext cx="586731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kumimoji="1" lang="en-IN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dditional file2: Fig. 2 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osaic ratio</a:t>
            </a:r>
            <a:r>
              <a:rPr kumimoji="1" lang="en-IN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 results</a:t>
            </a:r>
          </a:p>
        </p:txBody>
      </p:sp>
    </p:spTree>
    <p:extLst>
      <p:ext uri="{BB962C8B-B14F-4D97-AF65-F5344CB8AC3E}">
        <p14:creationId xmlns:p14="http://schemas.microsoft.com/office/powerpoint/2010/main" val="1404723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565</TotalTime>
  <Words>136</Words>
  <Application>Microsoft Macintosh PowerPoint</Application>
  <PresentationFormat>画面に合わせる 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murie</dc:creator>
  <cp:lastModifiedBy>河村 理恵</cp:lastModifiedBy>
  <cp:revision>942</cp:revision>
  <cp:lastPrinted>2021-05-14T02:46:54Z</cp:lastPrinted>
  <dcterms:created xsi:type="dcterms:W3CDTF">2020-02-20T14:12:31Z</dcterms:created>
  <dcterms:modified xsi:type="dcterms:W3CDTF">2021-06-24T14:06:43Z</dcterms:modified>
</cp:coreProperties>
</file>